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4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88" autoAdjust="0"/>
    <p:restoredTop sz="94660"/>
  </p:normalViewPr>
  <p:slideViewPr>
    <p:cSldViewPr snapToGrid="0">
      <p:cViewPr varScale="1">
        <p:scale>
          <a:sx n="83" d="100"/>
          <a:sy n="83" d="100"/>
        </p:scale>
        <p:origin x="28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hart of a number of colored dots&#10;&#10;Description automatically generated with medium confidence">
            <a:extLst>
              <a:ext uri="{FF2B5EF4-FFF2-40B4-BE49-F238E27FC236}">
                <a16:creationId xmlns:a16="http://schemas.microsoft.com/office/drawing/2014/main" id="{1641DCD0-094E-7421-1614-917E83A6C8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790" y="334291"/>
            <a:ext cx="3736632" cy="310297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8AD52AE-CB43-E4F7-0AB6-0075BC49896E}"/>
              </a:ext>
            </a:extLst>
          </p:cNvPr>
          <p:cNvSpPr txBox="1"/>
          <p:nvPr/>
        </p:nvSpPr>
        <p:spPr>
          <a:xfrm>
            <a:off x="232354" y="3524800"/>
            <a:ext cx="6393292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.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senchymal clusters isolated from Osx1-Cre or Atg7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/f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ice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form manifold approximation and projection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MAP) visualization of mesenchymal cells from endosteal bone preparations of 3-month-old control (Osx1-Cre) and autophagy-deficient (Atg7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f/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Osx1-Cre) male mice. Cell names and color codes are indicated at the right.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list of different colored circles&#10;&#10;Description automatically generated">
            <a:extLst>
              <a:ext uri="{FF2B5EF4-FFF2-40B4-BE49-F238E27FC236}">
                <a16:creationId xmlns:a16="http://schemas.microsoft.com/office/drawing/2014/main" id="{F039E53C-AA48-9AFE-4D91-C0A735ADF2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206" y="942004"/>
            <a:ext cx="1104516" cy="1887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500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95</TotalTime>
  <Words>59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62</cp:revision>
  <cp:lastPrinted>2024-12-12T18:09:24Z</cp:lastPrinted>
  <dcterms:created xsi:type="dcterms:W3CDTF">2024-09-05T13:29:40Z</dcterms:created>
  <dcterms:modified xsi:type="dcterms:W3CDTF">2025-07-02T22:47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